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676"/>
  </p:normalViewPr>
  <p:slideViewPr>
    <p:cSldViewPr snapToGrid="0">
      <p:cViewPr>
        <p:scale>
          <a:sx n="83" d="100"/>
          <a:sy n="83" d="100"/>
        </p:scale>
        <p:origin x="1936" y="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E2AEC4E-2347-4D80-2978-E814F1E8C5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E602A82-4BDC-8CEC-CD76-63ACBB18C6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7602CA-C60C-AB8F-E803-D9F432337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1970A1F-0343-5D4A-187E-55E139283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AFF892-81CC-8D7D-1404-7937CDB56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2053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29AEBC-9B4D-EBAC-1C0E-7371540BA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04E17F3-7355-E5BF-3F4C-C76294E5AE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FC00FD-C7CF-AF39-70AF-A5D5C68BA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1E41221-BCED-FC74-C6E9-A83FF93FC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8ABBDC-C826-DAEC-9945-0594B6CBB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1180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F7456C9-25E4-D889-C14A-0BEE69A31F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6A1034B-F2A0-FF38-6E9E-3B260B88B8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6900B5-02E3-2D0D-D90A-EB5F34341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71E3753-CF15-32A7-59AD-2B4E8D37F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2F3E9C-D546-8402-73AB-1C771ECC9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8447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53BF1C1-72B8-589C-E0F8-B8A6278DDA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E554EE-7CDB-02AB-1DFB-8F832D6445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19DF83F-6308-EA29-9F34-B8B315351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DCE6362-34EB-29D9-B558-96ADEF43B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F5FB343-8CA8-ED73-DFB7-9A7FE0081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58705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578F3D-7544-1C0A-D9F0-68A2429C6B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900C26D-770A-3760-B6A6-7FAE40094C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EE9CB02-0666-B2CC-C65D-4C606046B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1C68E91-C7D0-1AB5-3D00-4192BC8FE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1E3707D-5BDA-52AF-6596-F33F6B7FE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5450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F0E502-B744-5D4C-B774-D52A81268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7B139D3-C8A4-F0D2-869E-B8357A93AA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740F4AF-01B8-8A0D-CC9E-C923A385CA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F73E849-45DC-F912-C8B0-75C9FFEB1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4661A4B-E317-CC4F-10DD-04C5A3A99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F645DFA-3336-B252-0E64-5B5D3B2E3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2846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C4803D-9B61-0032-8B7F-780BFD3E8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4C11C8C-3524-A664-E313-9348D54028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760ABE6-026E-5DA9-B1CC-21E8CDCA3B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DCB3B68-9B4E-12B9-F3CB-F8CA8CB9C1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2D21110-3245-2003-F1A7-F5162D3138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CA3DC8F-3B3D-FBCA-B1F7-960A25346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855A448-45DD-97E9-DC31-F624E48CE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8220A64-9347-AF7B-96BA-AABDC850F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4290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48ED1EE-3C00-21F5-B00D-680A21B8B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D18D9AB-3D7C-AB60-864B-3841DB404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550C4D5-1D70-C9D1-878C-E6FBEFB0E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DC9C24-5009-2206-0E22-FD4AFAB14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667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A8F0644-D5CC-2237-FD45-9807CEDECE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6C6E630-8203-B7A5-E467-4A36EBF9B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15C66C7-90B4-5E07-5BB5-3C571F0AF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2164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721B3F-FB1B-BFD7-5804-D46590B51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A4D6453-84FF-1E9D-9CEA-1C7B5BEBEF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1068921-73C7-43A7-97B2-AC53AC6C65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9D0C272-A650-5F31-9E05-060C4377F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E71D41F-3F98-1DE2-3887-C7F079033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1DF6FCB-C7DD-F8BC-A910-E064EEB2B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72355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0F3F6CC-5694-EB27-D3C6-967015280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515A271-5FB7-6D2D-F9A4-EE9CD9140E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6A7810E-C293-7093-349E-A145AB21D8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2D6E2AE-B84F-8691-B393-629FCE99C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777E69F-AA4E-05DF-52A0-B87D8F5D2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683D340-7F61-6C6B-9F5A-8D8CC06C8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9424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D495D87-AE8A-4CB6-3C75-977FF14E2C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F1DC41F-9B78-6ACF-5B98-76C61E1B87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B30A567-7E74-45B4-B3EC-FCC5D4D550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C4EF7A-084E-B843-9AA5-FD7B15A7679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08E20DA-ABE2-2543-9AF7-56874CFFA6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A58217B-1118-71C0-2D43-90F8094086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76B3F91-EEFB-604C-A6D4-946B67BBC620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98439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>
            <a:extLst>
              <a:ext uri="{FF2B5EF4-FFF2-40B4-BE49-F238E27FC236}">
                <a16:creationId xmlns:a16="http://schemas.microsoft.com/office/drawing/2014/main" id="{98D4664A-BA4A-7EC6-45C6-D2409026E14C}"/>
              </a:ext>
            </a:extLst>
          </p:cNvPr>
          <p:cNvSpPr txBox="1"/>
          <p:nvPr/>
        </p:nvSpPr>
        <p:spPr>
          <a:xfrm>
            <a:off x="63146" y="2801743"/>
            <a:ext cx="7910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/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ECAD981-6C66-2C8D-296C-5FFEA967BD22}"/>
              </a:ext>
            </a:extLst>
          </p:cNvPr>
          <p:cNvSpPr txBox="1"/>
          <p:nvPr/>
        </p:nvSpPr>
        <p:spPr>
          <a:xfrm>
            <a:off x="5866579" y="2514301"/>
            <a:ext cx="10564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ERK 1/2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FF1D73F7-9B51-ACFA-0EA2-88A9FA5EDD53}"/>
              </a:ext>
            </a:extLst>
          </p:cNvPr>
          <p:cNvSpPr txBox="1"/>
          <p:nvPr/>
        </p:nvSpPr>
        <p:spPr>
          <a:xfrm>
            <a:off x="663297" y="6069868"/>
            <a:ext cx="30714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chrome c </a:t>
            </a:r>
            <a:r>
              <a:rPr lang="fr-CA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idase</a:t>
            </a:r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V</a:t>
            </a:r>
          </a:p>
        </p:txBody>
      </p:sp>
      <p:pic>
        <p:nvPicPr>
          <p:cNvPr id="9" name="Image 8" descr="Une image contenant texte&#10;&#10;Description générée automatiquement">
            <a:extLst>
              <a:ext uri="{FF2B5EF4-FFF2-40B4-BE49-F238E27FC236}">
                <a16:creationId xmlns:a16="http://schemas.microsoft.com/office/drawing/2014/main" id="{4DDC5F0E-E29E-57B1-4532-EC521F966E6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81" t="46226" r="21629" b="21385"/>
          <a:stretch/>
        </p:blipFill>
        <p:spPr>
          <a:xfrm>
            <a:off x="854244" y="1923002"/>
            <a:ext cx="4877732" cy="201909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Image 9" descr="Une image contenant texte, sombre&#10;&#10;Description générée automatiquement">
            <a:extLst>
              <a:ext uri="{FF2B5EF4-FFF2-40B4-BE49-F238E27FC236}">
                <a16:creationId xmlns:a16="http://schemas.microsoft.com/office/drawing/2014/main" id="{8EECF73B-98F2-6AE6-46B1-ED8E5A8BB72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43" t="43418" r="13596" b="35742"/>
          <a:stretch/>
        </p:blipFill>
        <p:spPr>
          <a:xfrm>
            <a:off x="2263673" y="5547717"/>
            <a:ext cx="4877732" cy="12994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3" name="Image 12" descr="Une image contenant texte&#10;&#10;Description générée automatiquement">
            <a:extLst>
              <a:ext uri="{FF2B5EF4-FFF2-40B4-BE49-F238E27FC236}">
                <a16:creationId xmlns:a16="http://schemas.microsoft.com/office/drawing/2014/main" id="{0C6E08FC-283B-7141-718F-910D87507CB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21" t="37220" r="19649" b="32842"/>
          <a:stretch/>
        </p:blipFill>
        <p:spPr>
          <a:xfrm>
            <a:off x="6861225" y="1840753"/>
            <a:ext cx="4807539" cy="18471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22" name="Groupe 21">
            <a:extLst>
              <a:ext uri="{FF2B5EF4-FFF2-40B4-BE49-F238E27FC236}">
                <a16:creationId xmlns:a16="http://schemas.microsoft.com/office/drawing/2014/main" id="{DCEF242C-9BF8-7039-0F44-0AECD8F3AF85}"/>
              </a:ext>
            </a:extLst>
          </p:cNvPr>
          <p:cNvGrpSpPr/>
          <p:nvPr/>
        </p:nvGrpSpPr>
        <p:grpSpPr>
          <a:xfrm>
            <a:off x="1166138" y="286185"/>
            <a:ext cx="3712768" cy="1644783"/>
            <a:chOff x="928643" y="-94387"/>
            <a:chExt cx="4055260" cy="1644783"/>
          </a:xfrm>
        </p:grpSpPr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D9DA68B4-5D8C-D679-DC07-9296E6FFAAD2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C1489229-5C81-15B1-4891-BBDF64B920DF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8FD2509A-F58D-2196-7067-9016F95199AF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4C3CDED0-D53A-0318-D207-D5E163EAD831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EF1EDA0B-7772-A325-27A3-6F16426D2B2D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72DAF13C-3143-774A-68A8-93CB027F8819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933A613E-C436-D1BC-2253-59796977691A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02973252-9533-E414-513C-79844F46E46B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6CBD5D95-0936-56A0-15C7-F0AB95E7ECFE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BC997A10-36A6-F3CB-1329-CA85D6E6BBB5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0BBB4FD8-8CEF-F040-FAD6-CEC87720D4B1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8C1AC144-FC00-9476-61BA-5CCCCE3ED3D5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EAEE661F-9DAB-BC95-E9E4-57A1FE1D2528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6A747F93-0600-F655-745C-EBD18DD69B97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37" name="Groupe 36">
            <a:extLst>
              <a:ext uri="{FF2B5EF4-FFF2-40B4-BE49-F238E27FC236}">
                <a16:creationId xmlns:a16="http://schemas.microsoft.com/office/drawing/2014/main" id="{7F64B1AA-19AC-7F9B-9FEA-FE556E6DB6C2}"/>
              </a:ext>
            </a:extLst>
          </p:cNvPr>
          <p:cNvGrpSpPr/>
          <p:nvPr/>
        </p:nvGrpSpPr>
        <p:grpSpPr>
          <a:xfrm>
            <a:off x="1761492" y="320058"/>
            <a:ext cx="3117414" cy="261610"/>
            <a:chOff x="5201446" y="-334391"/>
            <a:chExt cx="3117414" cy="261610"/>
          </a:xfrm>
        </p:grpSpPr>
        <p:cxnSp>
          <p:nvCxnSpPr>
            <p:cNvPr id="38" name="Connecteur droit 37">
              <a:extLst>
                <a:ext uri="{FF2B5EF4-FFF2-40B4-BE49-F238E27FC236}">
                  <a16:creationId xmlns:a16="http://schemas.microsoft.com/office/drawing/2014/main" id="{E4537535-F29E-0FA9-0395-D8A065E8049E}"/>
                </a:ext>
              </a:extLst>
            </p:cNvPr>
            <p:cNvCxnSpPr>
              <a:cxnSpLocks/>
            </p:cNvCxnSpPr>
            <p:nvPr/>
          </p:nvCxnSpPr>
          <p:spPr>
            <a:xfrm>
              <a:off x="5201446" y="-87088"/>
              <a:ext cx="3117414" cy="23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E9B806EA-4AA0-CBBB-FF6F-9AE7D1D8567E}"/>
                </a:ext>
              </a:extLst>
            </p:cNvPr>
            <p:cNvSpPr txBox="1"/>
            <p:nvPr/>
          </p:nvSpPr>
          <p:spPr>
            <a:xfrm>
              <a:off x="6379535" y="-334391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73" name="Groupe 72">
            <a:extLst>
              <a:ext uri="{FF2B5EF4-FFF2-40B4-BE49-F238E27FC236}">
                <a16:creationId xmlns:a16="http://schemas.microsoft.com/office/drawing/2014/main" id="{A75F4720-64D9-DC5B-C19D-7C7124B036B5}"/>
              </a:ext>
            </a:extLst>
          </p:cNvPr>
          <p:cNvGrpSpPr/>
          <p:nvPr/>
        </p:nvGrpSpPr>
        <p:grpSpPr>
          <a:xfrm>
            <a:off x="7956595" y="224067"/>
            <a:ext cx="2866706" cy="327613"/>
            <a:chOff x="5201446" y="-259094"/>
            <a:chExt cx="3117414" cy="174312"/>
          </a:xfrm>
        </p:grpSpPr>
        <p:cxnSp>
          <p:nvCxnSpPr>
            <p:cNvPr id="74" name="Connecteur droit 73">
              <a:extLst>
                <a:ext uri="{FF2B5EF4-FFF2-40B4-BE49-F238E27FC236}">
                  <a16:creationId xmlns:a16="http://schemas.microsoft.com/office/drawing/2014/main" id="{458316AA-4CBA-5BBD-A403-79AC1E75519D}"/>
                </a:ext>
              </a:extLst>
            </p:cNvPr>
            <p:cNvCxnSpPr>
              <a:cxnSpLocks/>
            </p:cNvCxnSpPr>
            <p:nvPr/>
          </p:nvCxnSpPr>
          <p:spPr>
            <a:xfrm>
              <a:off x="5201446" y="-87088"/>
              <a:ext cx="3117414" cy="23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ZoneTexte 74">
              <a:extLst>
                <a:ext uri="{FF2B5EF4-FFF2-40B4-BE49-F238E27FC236}">
                  <a16:creationId xmlns:a16="http://schemas.microsoft.com/office/drawing/2014/main" id="{6BEBE5E0-B380-0F32-BC53-327AE7D4AFFD}"/>
                </a:ext>
              </a:extLst>
            </p:cNvPr>
            <p:cNvSpPr txBox="1"/>
            <p:nvPr/>
          </p:nvSpPr>
          <p:spPr>
            <a:xfrm>
              <a:off x="6379535" y="-259094"/>
              <a:ext cx="1265457" cy="13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E782A07A-EB2E-722D-EFB0-AB223EA35877}"/>
              </a:ext>
            </a:extLst>
          </p:cNvPr>
          <p:cNvGrpSpPr/>
          <p:nvPr/>
        </p:nvGrpSpPr>
        <p:grpSpPr>
          <a:xfrm>
            <a:off x="7141405" y="248536"/>
            <a:ext cx="3712768" cy="1644783"/>
            <a:chOff x="928643" y="-94387"/>
            <a:chExt cx="4055260" cy="1644783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66E071BF-3025-A9B9-674C-D11CA7351B9E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8B2E229F-CECD-7A5F-45A0-F9AC56CF66FD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30767DBE-8C73-845D-6B79-F7AF369E13A8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5184DF22-A672-D0DF-353D-64E35B8646E6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9107AC49-FCBC-3EBB-EA57-AF94F566B36B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0C65B8BF-6CC3-F1C5-681E-3407838EF7B4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F0FD1D93-FD1F-7B6B-80A2-5BD07216DF2F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05C3B548-5B6A-6F1A-3187-1F2BF543D62D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DCA8316-3BDB-5197-FF19-B8F5F6121B01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E31C5AB9-4B41-23DA-156C-0A8738CBD952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B03ADD64-FAFF-B7C8-B913-5FF41D844460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D449E335-38A5-9259-97E9-F2772421F7B1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3EE1ED9E-945D-9615-7F79-F72A87B93625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id="{5D88EF2C-FB39-B5C7-3654-09AD16859871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78" name="Groupe 77">
            <a:extLst>
              <a:ext uri="{FF2B5EF4-FFF2-40B4-BE49-F238E27FC236}">
                <a16:creationId xmlns:a16="http://schemas.microsoft.com/office/drawing/2014/main" id="{0912DCE2-49B7-A0EF-165D-54290B124621}"/>
              </a:ext>
            </a:extLst>
          </p:cNvPr>
          <p:cNvGrpSpPr/>
          <p:nvPr/>
        </p:nvGrpSpPr>
        <p:grpSpPr>
          <a:xfrm>
            <a:off x="2643629" y="3922931"/>
            <a:ext cx="3712768" cy="1644783"/>
            <a:chOff x="928643" y="-94387"/>
            <a:chExt cx="4055260" cy="1644783"/>
          </a:xfrm>
        </p:grpSpPr>
        <p:sp>
          <p:nvSpPr>
            <p:cNvPr id="79" name="ZoneTexte 78">
              <a:extLst>
                <a:ext uri="{FF2B5EF4-FFF2-40B4-BE49-F238E27FC236}">
                  <a16:creationId xmlns:a16="http://schemas.microsoft.com/office/drawing/2014/main" id="{4570043E-9799-6196-F11B-F9C3924C75CD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80" name="ZoneTexte 79">
              <a:extLst>
                <a:ext uri="{FF2B5EF4-FFF2-40B4-BE49-F238E27FC236}">
                  <a16:creationId xmlns:a16="http://schemas.microsoft.com/office/drawing/2014/main" id="{6DD5874D-320E-C95F-A988-22D9473D1A72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81" name="ZoneTexte 80">
              <a:extLst>
                <a:ext uri="{FF2B5EF4-FFF2-40B4-BE49-F238E27FC236}">
                  <a16:creationId xmlns:a16="http://schemas.microsoft.com/office/drawing/2014/main" id="{BCF65411-65A1-DDE9-7868-BC3E8DA360BE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82" name="ZoneTexte 81">
              <a:extLst>
                <a:ext uri="{FF2B5EF4-FFF2-40B4-BE49-F238E27FC236}">
                  <a16:creationId xmlns:a16="http://schemas.microsoft.com/office/drawing/2014/main" id="{D1BC89AA-FFD5-80A9-67F2-725EAC29C19B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83" name="ZoneTexte 82">
              <a:extLst>
                <a:ext uri="{FF2B5EF4-FFF2-40B4-BE49-F238E27FC236}">
                  <a16:creationId xmlns:a16="http://schemas.microsoft.com/office/drawing/2014/main" id="{2A6AA04F-C2E6-933E-41F7-90FACFE24ED6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84" name="ZoneTexte 83">
              <a:extLst>
                <a:ext uri="{FF2B5EF4-FFF2-40B4-BE49-F238E27FC236}">
                  <a16:creationId xmlns:a16="http://schemas.microsoft.com/office/drawing/2014/main" id="{DFBC3DB9-8C72-61E9-3479-5F12C065A4A1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85" name="ZoneTexte 84">
              <a:extLst>
                <a:ext uri="{FF2B5EF4-FFF2-40B4-BE49-F238E27FC236}">
                  <a16:creationId xmlns:a16="http://schemas.microsoft.com/office/drawing/2014/main" id="{22F5FA95-ECE8-8A37-D7DD-66BE42A1962D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86" name="ZoneTexte 85">
              <a:extLst>
                <a:ext uri="{FF2B5EF4-FFF2-40B4-BE49-F238E27FC236}">
                  <a16:creationId xmlns:a16="http://schemas.microsoft.com/office/drawing/2014/main" id="{65F61EEA-FA9D-58AF-609A-BC95E8F6849D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87" name="ZoneTexte 86">
              <a:extLst>
                <a:ext uri="{FF2B5EF4-FFF2-40B4-BE49-F238E27FC236}">
                  <a16:creationId xmlns:a16="http://schemas.microsoft.com/office/drawing/2014/main" id="{0DC5F05E-0EAA-665B-C01F-B573CAE87F2A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id="{5FE4C0AF-BC55-BF59-FBFC-D6FB41B4E025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89" name="ZoneTexte 88">
              <a:extLst>
                <a:ext uri="{FF2B5EF4-FFF2-40B4-BE49-F238E27FC236}">
                  <a16:creationId xmlns:a16="http://schemas.microsoft.com/office/drawing/2014/main" id="{A002C73C-B5EA-C7E1-865B-970B4E71B1F6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EFBEFA81-A213-297E-5C7A-AF43DEC37892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E63B3C4F-D0C1-97FF-471E-C22BA4AA6F1F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C789E7EA-434F-AD0B-BE2A-7757510ADD27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93" name="Groupe 92">
            <a:extLst>
              <a:ext uri="{FF2B5EF4-FFF2-40B4-BE49-F238E27FC236}">
                <a16:creationId xmlns:a16="http://schemas.microsoft.com/office/drawing/2014/main" id="{C74B9E78-3935-37B5-FE86-86953412DC0B}"/>
              </a:ext>
            </a:extLst>
          </p:cNvPr>
          <p:cNvGrpSpPr/>
          <p:nvPr/>
        </p:nvGrpSpPr>
        <p:grpSpPr>
          <a:xfrm>
            <a:off x="3238983" y="3956804"/>
            <a:ext cx="3117414" cy="261610"/>
            <a:chOff x="5201446" y="-334391"/>
            <a:chExt cx="3117414" cy="261610"/>
          </a:xfrm>
        </p:grpSpPr>
        <p:cxnSp>
          <p:nvCxnSpPr>
            <p:cNvPr id="94" name="Connecteur droit 93">
              <a:extLst>
                <a:ext uri="{FF2B5EF4-FFF2-40B4-BE49-F238E27FC236}">
                  <a16:creationId xmlns:a16="http://schemas.microsoft.com/office/drawing/2014/main" id="{65FF649A-EFDB-AC3B-3D6D-5014145EF768}"/>
                </a:ext>
              </a:extLst>
            </p:cNvPr>
            <p:cNvCxnSpPr>
              <a:cxnSpLocks/>
            </p:cNvCxnSpPr>
            <p:nvPr/>
          </p:nvCxnSpPr>
          <p:spPr>
            <a:xfrm>
              <a:off x="5201446" y="-87088"/>
              <a:ext cx="3117414" cy="23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309D6972-C33E-EE73-2A16-002FA60FFD00}"/>
                </a:ext>
              </a:extLst>
            </p:cNvPr>
            <p:cNvSpPr txBox="1"/>
            <p:nvPr/>
          </p:nvSpPr>
          <p:spPr>
            <a:xfrm>
              <a:off x="6379535" y="-334391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96" name="Groupe 95">
            <a:extLst>
              <a:ext uri="{FF2B5EF4-FFF2-40B4-BE49-F238E27FC236}">
                <a16:creationId xmlns:a16="http://schemas.microsoft.com/office/drawing/2014/main" id="{8DBD8949-CCFF-EEA4-4EDD-B3904B299328}"/>
              </a:ext>
            </a:extLst>
          </p:cNvPr>
          <p:cNvGrpSpPr/>
          <p:nvPr/>
        </p:nvGrpSpPr>
        <p:grpSpPr>
          <a:xfrm>
            <a:off x="6799692" y="2148141"/>
            <a:ext cx="774864" cy="1395117"/>
            <a:chOff x="1753223" y="1617671"/>
            <a:chExt cx="774864" cy="1395117"/>
          </a:xfrm>
        </p:grpSpPr>
        <p:grpSp>
          <p:nvGrpSpPr>
            <p:cNvPr id="97" name="Groupe 96">
              <a:extLst>
                <a:ext uri="{FF2B5EF4-FFF2-40B4-BE49-F238E27FC236}">
                  <a16:creationId xmlns:a16="http://schemas.microsoft.com/office/drawing/2014/main" id="{E5038C8F-AF16-257C-5487-3CFBE315FEE9}"/>
                </a:ext>
              </a:extLst>
            </p:cNvPr>
            <p:cNvGrpSpPr/>
            <p:nvPr/>
          </p:nvGrpSpPr>
          <p:grpSpPr>
            <a:xfrm>
              <a:off x="1753223" y="1617671"/>
              <a:ext cx="774864" cy="881526"/>
              <a:chOff x="1588028" y="2089543"/>
              <a:chExt cx="774864" cy="881526"/>
            </a:xfrm>
          </p:grpSpPr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6B87634C-5E48-D03A-FF9C-0ADDCC0FBB42}"/>
                  </a:ext>
                </a:extLst>
              </p:cNvPr>
              <p:cNvSpPr txBox="1"/>
              <p:nvPr/>
            </p:nvSpPr>
            <p:spPr>
              <a:xfrm>
                <a:off x="1609170" y="2468866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75</a:t>
                </a:r>
                <a:endParaRPr lang="en-CA" sz="1000" dirty="0"/>
              </a:p>
            </p:txBody>
          </p:sp>
          <p:sp>
            <p:nvSpPr>
              <p:cNvPr id="101" name="ZoneTexte 100">
                <a:extLst>
                  <a:ext uri="{FF2B5EF4-FFF2-40B4-BE49-F238E27FC236}">
                    <a16:creationId xmlns:a16="http://schemas.microsoft.com/office/drawing/2014/main" id="{0F9A9784-B617-C276-8BD0-F2E4197DA6B7}"/>
                  </a:ext>
                </a:extLst>
              </p:cNvPr>
              <p:cNvSpPr txBox="1"/>
              <p:nvPr/>
            </p:nvSpPr>
            <p:spPr>
              <a:xfrm>
                <a:off x="1602115" y="2648527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50</a:t>
                </a:r>
                <a:endParaRPr lang="en-CA" sz="1000" dirty="0"/>
              </a:p>
            </p:txBody>
          </p:sp>
          <p:sp>
            <p:nvSpPr>
              <p:cNvPr id="102" name="ZoneTexte 101">
                <a:extLst>
                  <a:ext uri="{FF2B5EF4-FFF2-40B4-BE49-F238E27FC236}">
                    <a16:creationId xmlns:a16="http://schemas.microsoft.com/office/drawing/2014/main" id="{BC4D4EF3-829E-D8F5-A929-B504D8020FB0}"/>
                  </a:ext>
                </a:extLst>
              </p:cNvPr>
              <p:cNvSpPr txBox="1"/>
              <p:nvPr/>
            </p:nvSpPr>
            <p:spPr>
              <a:xfrm>
                <a:off x="1588028" y="2817181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37</a:t>
                </a:r>
                <a:endParaRPr lang="en-CA" sz="1000" dirty="0"/>
              </a:p>
            </p:txBody>
          </p:sp>
          <p:sp>
            <p:nvSpPr>
              <p:cNvPr id="103" name="ZoneTexte 102">
                <a:extLst>
                  <a:ext uri="{FF2B5EF4-FFF2-40B4-BE49-F238E27FC236}">
                    <a16:creationId xmlns:a16="http://schemas.microsoft.com/office/drawing/2014/main" id="{D93A46B8-2BDF-AFCA-3D82-DFBD28F74943}"/>
                  </a:ext>
                </a:extLst>
              </p:cNvPr>
              <p:cNvSpPr txBox="1"/>
              <p:nvPr/>
            </p:nvSpPr>
            <p:spPr>
              <a:xfrm>
                <a:off x="1592948" y="2285524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50</a:t>
                </a:r>
                <a:endParaRPr lang="en-CA" sz="1000" dirty="0"/>
              </a:p>
            </p:txBody>
          </p:sp>
          <p:sp>
            <p:nvSpPr>
              <p:cNvPr id="104" name="ZoneTexte 103">
                <a:extLst>
                  <a:ext uri="{FF2B5EF4-FFF2-40B4-BE49-F238E27FC236}">
                    <a16:creationId xmlns:a16="http://schemas.microsoft.com/office/drawing/2014/main" id="{3F14B76B-D8A3-BC6F-A369-65462DE47564}"/>
                  </a:ext>
                </a:extLst>
              </p:cNvPr>
              <p:cNvSpPr txBox="1"/>
              <p:nvPr/>
            </p:nvSpPr>
            <p:spPr>
              <a:xfrm>
                <a:off x="1592949" y="2361427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00</a:t>
                </a:r>
                <a:endParaRPr lang="en-CA" sz="1000" dirty="0"/>
              </a:p>
            </p:txBody>
          </p:sp>
          <p:sp>
            <p:nvSpPr>
              <p:cNvPr id="105" name="ZoneTexte 104">
                <a:extLst>
                  <a:ext uri="{FF2B5EF4-FFF2-40B4-BE49-F238E27FC236}">
                    <a16:creationId xmlns:a16="http://schemas.microsoft.com/office/drawing/2014/main" id="{DC27DD05-8386-7F50-6770-51CA4ADC2867}"/>
                  </a:ext>
                </a:extLst>
              </p:cNvPr>
              <p:cNvSpPr txBox="1"/>
              <p:nvPr/>
            </p:nvSpPr>
            <p:spPr>
              <a:xfrm>
                <a:off x="1592948" y="2196215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250</a:t>
                </a:r>
                <a:endParaRPr lang="en-CA" sz="1000" dirty="0"/>
              </a:p>
            </p:txBody>
          </p:sp>
          <p:sp>
            <p:nvSpPr>
              <p:cNvPr id="106" name="ZoneTexte 105">
                <a:extLst>
                  <a:ext uri="{FF2B5EF4-FFF2-40B4-BE49-F238E27FC236}">
                    <a16:creationId xmlns:a16="http://schemas.microsoft.com/office/drawing/2014/main" id="{1F677636-A511-C46F-0E1C-9BC1DAB8A786}"/>
                  </a:ext>
                </a:extLst>
              </p:cNvPr>
              <p:cNvSpPr txBox="1"/>
              <p:nvPr/>
            </p:nvSpPr>
            <p:spPr>
              <a:xfrm>
                <a:off x="1634022" y="2089543"/>
                <a:ext cx="7288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 err="1"/>
                  <a:t>kDa</a:t>
                </a:r>
                <a:endParaRPr lang="en-CA" sz="1000" dirty="0"/>
              </a:p>
            </p:txBody>
          </p:sp>
        </p:grp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E739923D-3642-0E48-05CD-B0146A7492BF}"/>
                </a:ext>
              </a:extLst>
            </p:cNvPr>
            <p:cNvSpPr txBox="1"/>
            <p:nvPr/>
          </p:nvSpPr>
          <p:spPr>
            <a:xfrm>
              <a:off x="1755308" y="2689306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5</a:t>
              </a:r>
              <a:endParaRPr lang="en-CA" sz="1000" dirty="0"/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4958936A-0633-2A76-2C71-6F9F177AE7F4}"/>
                </a:ext>
              </a:extLst>
            </p:cNvPr>
            <p:cNvSpPr txBox="1"/>
            <p:nvPr/>
          </p:nvSpPr>
          <p:spPr>
            <a:xfrm>
              <a:off x="1753223" y="2858900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0</a:t>
              </a:r>
              <a:endParaRPr lang="en-CA" sz="1000" dirty="0"/>
            </a:p>
          </p:txBody>
        </p:sp>
      </p:grpSp>
      <p:grpSp>
        <p:nvGrpSpPr>
          <p:cNvPr id="107" name="Groupe 106">
            <a:extLst>
              <a:ext uri="{FF2B5EF4-FFF2-40B4-BE49-F238E27FC236}">
                <a16:creationId xmlns:a16="http://schemas.microsoft.com/office/drawing/2014/main" id="{B355E8F7-D0DA-9F72-FA0B-AAEAA9B2B7EA}"/>
              </a:ext>
            </a:extLst>
          </p:cNvPr>
          <p:cNvGrpSpPr/>
          <p:nvPr/>
        </p:nvGrpSpPr>
        <p:grpSpPr>
          <a:xfrm>
            <a:off x="771695" y="2163454"/>
            <a:ext cx="774864" cy="1395117"/>
            <a:chOff x="1753223" y="1617671"/>
            <a:chExt cx="774864" cy="1395117"/>
          </a:xfrm>
        </p:grpSpPr>
        <p:grpSp>
          <p:nvGrpSpPr>
            <p:cNvPr id="108" name="Groupe 107">
              <a:extLst>
                <a:ext uri="{FF2B5EF4-FFF2-40B4-BE49-F238E27FC236}">
                  <a16:creationId xmlns:a16="http://schemas.microsoft.com/office/drawing/2014/main" id="{694EED34-2809-196F-B015-4273273ACD86}"/>
                </a:ext>
              </a:extLst>
            </p:cNvPr>
            <p:cNvGrpSpPr/>
            <p:nvPr/>
          </p:nvGrpSpPr>
          <p:grpSpPr>
            <a:xfrm>
              <a:off x="1753223" y="1617671"/>
              <a:ext cx="774864" cy="881526"/>
              <a:chOff x="1588028" y="2089543"/>
              <a:chExt cx="774864" cy="881526"/>
            </a:xfrm>
          </p:grpSpPr>
          <p:sp>
            <p:nvSpPr>
              <p:cNvPr id="111" name="ZoneTexte 110">
                <a:extLst>
                  <a:ext uri="{FF2B5EF4-FFF2-40B4-BE49-F238E27FC236}">
                    <a16:creationId xmlns:a16="http://schemas.microsoft.com/office/drawing/2014/main" id="{6DA5932E-13C0-15E4-1707-69DA6113072E}"/>
                  </a:ext>
                </a:extLst>
              </p:cNvPr>
              <p:cNvSpPr txBox="1"/>
              <p:nvPr/>
            </p:nvSpPr>
            <p:spPr>
              <a:xfrm>
                <a:off x="1609170" y="2468866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>
                    <a:solidFill>
                      <a:schemeClr val="bg1"/>
                    </a:solidFill>
                  </a:rPr>
                  <a:t>75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2" name="ZoneTexte 111">
                <a:extLst>
                  <a:ext uri="{FF2B5EF4-FFF2-40B4-BE49-F238E27FC236}">
                    <a16:creationId xmlns:a16="http://schemas.microsoft.com/office/drawing/2014/main" id="{037B956A-26D6-7D41-60BC-6D6A5BB09E25}"/>
                  </a:ext>
                </a:extLst>
              </p:cNvPr>
              <p:cNvSpPr txBox="1"/>
              <p:nvPr/>
            </p:nvSpPr>
            <p:spPr>
              <a:xfrm>
                <a:off x="1602115" y="2648527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>
                    <a:solidFill>
                      <a:schemeClr val="bg1"/>
                    </a:solidFill>
                  </a:rPr>
                  <a:t>50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3" name="ZoneTexte 112">
                <a:extLst>
                  <a:ext uri="{FF2B5EF4-FFF2-40B4-BE49-F238E27FC236}">
                    <a16:creationId xmlns:a16="http://schemas.microsoft.com/office/drawing/2014/main" id="{20EA9B6C-9C6B-45AB-49FC-7E398E6A29A2}"/>
                  </a:ext>
                </a:extLst>
              </p:cNvPr>
              <p:cNvSpPr txBox="1"/>
              <p:nvPr/>
            </p:nvSpPr>
            <p:spPr>
              <a:xfrm>
                <a:off x="1588028" y="2817181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>
                    <a:solidFill>
                      <a:schemeClr val="bg1"/>
                    </a:solidFill>
                  </a:rPr>
                  <a:t>37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4" name="ZoneTexte 113">
                <a:extLst>
                  <a:ext uri="{FF2B5EF4-FFF2-40B4-BE49-F238E27FC236}">
                    <a16:creationId xmlns:a16="http://schemas.microsoft.com/office/drawing/2014/main" id="{4CB92DDC-43F0-D42D-E421-8DC15A4130CA}"/>
                  </a:ext>
                </a:extLst>
              </p:cNvPr>
              <p:cNvSpPr txBox="1"/>
              <p:nvPr/>
            </p:nvSpPr>
            <p:spPr>
              <a:xfrm>
                <a:off x="1592948" y="2285524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>
                    <a:solidFill>
                      <a:schemeClr val="bg1"/>
                    </a:solidFill>
                  </a:rPr>
                  <a:t>150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7FC4DE4D-432C-BC22-2D06-9A20D78CD591}"/>
                  </a:ext>
                </a:extLst>
              </p:cNvPr>
              <p:cNvSpPr txBox="1"/>
              <p:nvPr/>
            </p:nvSpPr>
            <p:spPr>
              <a:xfrm>
                <a:off x="1592949" y="2361427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>
                    <a:solidFill>
                      <a:schemeClr val="bg1"/>
                    </a:solidFill>
                  </a:rPr>
                  <a:t>100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D89527F1-6C39-6264-5D45-DC05A86294B8}"/>
                  </a:ext>
                </a:extLst>
              </p:cNvPr>
              <p:cNvSpPr txBox="1"/>
              <p:nvPr/>
            </p:nvSpPr>
            <p:spPr>
              <a:xfrm>
                <a:off x="1592948" y="2196215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>
                    <a:solidFill>
                      <a:schemeClr val="bg1"/>
                    </a:solidFill>
                  </a:rPr>
                  <a:t>250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31CEFCD6-E5B4-8F93-B148-FF9BEE0897D2}"/>
                  </a:ext>
                </a:extLst>
              </p:cNvPr>
              <p:cNvSpPr txBox="1"/>
              <p:nvPr/>
            </p:nvSpPr>
            <p:spPr>
              <a:xfrm>
                <a:off x="1634022" y="2089543"/>
                <a:ext cx="7288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 err="1">
                    <a:solidFill>
                      <a:schemeClr val="bg1"/>
                    </a:solidFill>
                  </a:rPr>
                  <a:t>kDa</a:t>
                </a:r>
                <a:endParaRPr lang="en-CA" sz="10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09" name="ZoneTexte 108">
              <a:extLst>
                <a:ext uri="{FF2B5EF4-FFF2-40B4-BE49-F238E27FC236}">
                  <a16:creationId xmlns:a16="http://schemas.microsoft.com/office/drawing/2014/main" id="{6054C491-24B0-4825-2906-9F34F68DCD2D}"/>
                </a:ext>
              </a:extLst>
            </p:cNvPr>
            <p:cNvSpPr txBox="1"/>
            <p:nvPr/>
          </p:nvSpPr>
          <p:spPr>
            <a:xfrm>
              <a:off x="1755308" y="2689306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>
                  <a:solidFill>
                    <a:schemeClr val="bg1"/>
                  </a:solidFill>
                </a:rPr>
                <a:t>25</a:t>
              </a:r>
              <a:endParaRPr lang="en-CA" sz="1000" dirty="0">
                <a:solidFill>
                  <a:schemeClr val="bg1"/>
                </a:solidFill>
              </a:endParaRPr>
            </a:p>
          </p:txBody>
        </p:sp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42E42015-9AC1-7074-B37B-78AEB15F9F79}"/>
                </a:ext>
              </a:extLst>
            </p:cNvPr>
            <p:cNvSpPr txBox="1"/>
            <p:nvPr/>
          </p:nvSpPr>
          <p:spPr>
            <a:xfrm>
              <a:off x="1753223" y="2858900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>
                  <a:solidFill>
                    <a:schemeClr val="bg1"/>
                  </a:solidFill>
                </a:rPr>
                <a:t>20</a:t>
              </a:r>
              <a:endParaRPr lang="en-CA" sz="10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33" name="Groupe 132">
            <a:extLst>
              <a:ext uri="{FF2B5EF4-FFF2-40B4-BE49-F238E27FC236}">
                <a16:creationId xmlns:a16="http://schemas.microsoft.com/office/drawing/2014/main" id="{A24C1FDA-CE19-1AB9-B4AE-3B7B7A773E1C}"/>
              </a:ext>
            </a:extLst>
          </p:cNvPr>
          <p:cNvGrpSpPr/>
          <p:nvPr/>
        </p:nvGrpSpPr>
        <p:grpSpPr>
          <a:xfrm>
            <a:off x="2345469" y="5704063"/>
            <a:ext cx="728870" cy="586576"/>
            <a:chOff x="1900894" y="4154708"/>
            <a:chExt cx="728870" cy="586576"/>
          </a:xfrm>
        </p:grpSpPr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E71F5759-EEA1-9FC0-95E1-23F10B38402C}"/>
                </a:ext>
              </a:extLst>
            </p:cNvPr>
            <p:cNvSpPr txBox="1"/>
            <p:nvPr/>
          </p:nvSpPr>
          <p:spPr>
            <a:xfrm>
              <a:off x="1946661" y="4363902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>
                  <a:solidFill>
                    <a:schemeClr val="bg1"/>
                  </a:solidFill>
                </a:rPr>
                <a:t>15</a:t>
              </a:r>
              <a:endParaRPr lang="en-CA" sz="1000" dirty="0">
                <a:solidFill>
                  <a:schemeClr val="bg1"/>
                </a:solidFill>
              </a:endParaRPr>
            </a:p>
          </p:txBody>
        </p:sp>
        <p:sp>
          <p:nvSpPr>
            <p:cNvPr id="135" name="ZoneTexte 134">
              <a:extLst>
                <a:ext uri="{FF2B5EF4-FFF2-40B4-BE49-F238E27FC236}">
                  <a16:creationId xmlns:a16="http://schemas.microsoft.com/office/drawing/2014/main" id="{76AC47C2-39C1-BC44-F6FD-56622C930DC2}"/>
                </a:ext>
              </a:extLst>
            </p:cNvPr>
            <p:cNvSpPr txBox="1"/>
            <p:nvPr/>
          </p:nvSpPr>
          <p:spPr>
            <a:xfrm>
              <a:off x="1979013" y="4587396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>
                  <a:solidFill>
                    <a:schemeClr val="bg1"/>
                  </a:solidFill>
                </a:rPr>
                <a:t>10</a:t>
              </a:r>
              <a:endParaRPr lang="en-CA" sz="1000" dirty="0">
                <a:solidFill>
                  <a:schemeClr val="bg1"/>
                </a:solidFill>
              </a:endParaRPr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F6D9FCF5-A3A9-9504-432C-E6B87B5CF56C}"/>
                </a:ext>
              </a:extLst>
            </p:cNvPr>
            <p:cNvSpPr txBox="1"/>
            <p:nvPr/>
          </p:nvSpPr>
          <p:spPr>
            <a:xfrm>
              <a:off x="1900894" y="4154708"/>
              <a:ext cx="7288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 err="1">
                  <a:solidFill>
                    <a:schemeClr val="bg1"/>
                  </a:solidFill>
                </a:rPr>
                <a:t>kDa</a:t>
              </a:r>
              <a:endParaRPr lang="en-CA" sz="1000" dirty="0">
                <a:solidFill>
                  <a:schemeClr val="bg1"/>
                </a:solidFill>
              </a:endParaRPr>
            </a:p>
          </p:txBody>
        </p:sp>
      </p:grpSp>
      <p:sp>
        <p:nvSpPr>
          <p:cNvPr id="137" name="Rectangle 136">
            <a:extLst>
              <a:ext uri="{FF2B5EF4-FFF2-40B4-BE49-F238E27FC236}">
                <a16:creationId xmlns:a16="http://schemas.microsoft.com/office/drawing/2014/main" id="{B4B1ADB1-E58F-0C42-883A-20F53814C5A6}"/>
              </a:ext>
            </a:extLst>
          </p:cNvPr>
          <p:cNvSpPr/>
          <p:nvPr/>
        </p:nvSpPr>
        <p:spPr>
          <a:xfrm>
            <a:off x="1166138" y="2851320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138" name="Groupe 137">
            <a:extLst>
              <a:ext uri="{FF2B5EF4-FFF2-40B4-BE49-F238E27FC236}">
                <a16:creationId xmlns:a16="http://schemas.microsoft.com/office/drawing/2014/main" id="{D7D09DB5-2193-A813-0A77-E356A6C40B86}"/>
              </a:ext>
            </a:extLst>
          </p:cNvPr>
          <p:cNvGrpSpPr/>
          <p:nvPr/>
        </p:nvGrpSpPr>
        <p:grpSpPr>
          <a:xfrm>
            <a:off x="7914338" y="4379957"/>
            <a:ext cx="3588047" cy="1024071"/>
            <a:chOff x="2120020" y="4318523"/>
            <a:chExt cx="3588047" cy="1024071"/>
          </a:xfrm>
        </p:grpSpPr>
        <p:grpSp>
          <p:nvGrpSpPr>
            <p:cNvPr id="139" name="Groupe 138">
              <a:extLst>
                <a:ext uri="{FF2B5EF4-FFF2-40B4-BE49-F238E27FC236}">
                  <a16:creationId xmlns:a16="http://schemas.microsoft.com/office/drawing/2014/main" id="{47A67A14-7A3E-5936-61FA-6EEF7DF33AB2}"/>
                </a:ext>
              </a:extLst>
            </p:cNvPr>
            <p:cNvGrpSpPr/>
            <p:nvPr/>
          </p:nvGrpSpPr>
          <p:grpSpPr>
            <a:xfrm>
              <a:off x="2120020" y="4318523"/>
              <a:ext cx="3588047" cy="1024071"/>
              <a:chOff x="2120020" y="4318523"/>
              <a:chExt cx="3588047" cy="1024071"/>
            </a:xfrm>
          </p:grpSpPr>
          <p:grpSp>
            <p:nvGrpSpPr>
              <p:cNvPr id="142" name="Groupe 141">
                <a:extLst>
                  <a:ext uri="{FF2B5EF4-FFF2-40B4-BE49-F238E27FC236}">
                    <a16:creationId xmlns:a16="http://schemas.microsoft.com/office/drawing/2014/main" id="{2869FF18-AE4D-1AC3-5CE7-D4757FB1EFCF}"/>
                  </a:ext>
                </a:extLst>
              </p:cNvPr>
              <p:cNvGrpSpPr/>
              <p:nvPr/>
            </p:nvGrpSpPr>
            <p:grpSpPr>
              <a:xfrm>
                <a:off x="2120020" y="4318523"/>
                <a:ext cx="3588047" cy="1024071"/>
                <a:chOff x="2120020" y="4318523"/>
                <a:chExt cx="3588047" cy="1024071"/>
              </a:xfrm>
            </p:grpSpPr>
            <p:grpSp>
              <p:nvGrpSpPr>
                <p:cNvPr id="146" name="Groupe 145">
                  <a:extLst>
                    <a:ext uri="{FF2B5EF4-FFF2-40B4-BE49-F238E27FC236}">
                      <a16:creationId xmlns:a16="http://schemas.microsoft.com/office/drawing/2014/main" id="{54C56641-FCEC-9EF7-9004-997803AFFC18}"/>
                    </a:ext>
                  </a:extLst>
                </p:cNvPr>
                <p:cNvGrpSpPr/>
                <p:nvPr/>
              </p:nvGrpSpPr>
              <p:grpSpPr>
                <a:xfrm>
                  <a:off x="2120020" y="4318523"/>
                  <a:ext cx="3588047" cy="1024071"/>
                  <a:chOff x="4028346" y="4953916"/>
                  <a:chExt cx="3588047" cy="1024071"/>
                </a:xfrm>
              </p:grpSpPr>
              <p:grpSp>
                <p:nvGrpSpPr>
                  <p:cNvPr id="150" name="Groupe 149">
                    <a:extLst>
                      <a:ext uri="{FF2B5EF4-FFF2-40B4-BE49-F238E27FC236}">
                        <a16:creationId xmlns:a16="http://schemas.microsoft.com/office/drawing/2014/main" id="{B8BE7720-2AEF-5260-EF01-A8B837694914}"/>
                      </a:ext>
                    </a:extLst>
                  </p:cNvPr>
                  <p:cNvGrpSpPr/>
                  <p:nvPr/>
                </p:nvGrpSpPr>
                <p:grpSpPr>
                  <a:xfrm>
                    <a:off x="4028346" y="5383811"/>
                    <a:ext cx="3588047" cy="594176"/>
                    <a:chOff x="3767887" y="3252778"/>
                    <a:chExt cx="3588047" cy="594176"/>
                  </a:xfrm>
                </p:grpSpPr>
                <p:sp>
                  <p:nvSpPr>
                    <p:cNvPr id="160" name="ZoneTexte 159">
                      <a:extLst>
                        <a:ext uri="{FF2B5EF4-FFF2-40B4-BE49-F238E27FC236}">
                          <a16:creationId xmlns:a16="http://schemas.microsoft.com/office/drawing/2014/main" id="{5D32C4BD-22DB-BAA7-D3EB-5F85DBF74CD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67887" y="3282391"/>
                      <a:ext cx="791098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K</a:t>
                      </a:r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/2</a:t>
                      </a:r>
                    </a:p>
                  </p:txBody>
                </p:sp>
                <p:sp>
                  <p:nvSpPr>
                    <p:cNvPr id="161" name="ZoneTexte 160">
                      <a:extLst>
                        <a:ext uri="{FF2B5EF4-FFF2-40B4-BE49-F238E27FC236}">
                          <a16:creationId xmlns:a16="http://schemas.microsoft.com/office/drawing/2014/main" id="{26D8F16D-91F8-D848-B2F6-C317794E33E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64066" y="3252778"/>
                      <a:ext cx="97819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 kDa</a:t>
                      </a:r>
                    </a:p>
                  </p:txBody>
                </p:sp>
                <p:sp>
                  <p:nvSpPr>
                    <p:cNvPr id="162" name="ZoneTexte 161">
                      <a:extLst>
                        <a:ext uri="{FF2B5EF4-FFF2-40B4-BE49-F238E27FC236}">
                          <a16:creationId xmlns:a16="http://schemas.microsoft.com/office/drawing/2014/main" id="{7253CDE9-DEB2-41C3-9CD1-3A606C3699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67330" y="3342455"/>
                      <a:ext cx="97819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 kDa</a:t>
                      </a:r>
                    </a:p>
                  </p:txBody>
                </p:sp>
                <p:sp>
                  <p:nvSpPr>
                    <p:cNvPr id="163" name="ZoneTexte 162">
                      <a:extLst>
                        <a:ext uri="{FF2B5EF4-FFF2-40B4-BE49-F238E27FC236}">
                          <a16:creationId xmlns:a16="http://schemas.microsoft.com/office/drawing/2014/main" id="{C75A4E71-1776-4B7B-DF55-AC36F59AB1F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77737" y="3533076"/>
                      <a:ext cx="97819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 kDa</a:t>
                      </a:r>
                    </a:p>
                  </p:txBody>
                </p:sp>
                <p:sp>
                  <p:nvSpPr>
                    <p:cNvPr id="164" name="ZoneTexte 163">
                      <a:extLst>
                        <a:ext uri="{FF2B5EF4-FFF2-40B4-BE49-F238E27FC236}">
                          <a16:creationId xmlns:a16="http://schemas.microsoft.com/office/drawing/2014/main" id="{F25FC47A-C959-B63B-67AC-0F60458495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99423" y="3575376"/>
                      <a:ext cx="105649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K</a:t>
                      </a:r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/2</a:t>
                      </a:r>
                    </a:p>
                  </p:txBody>
                </p:sp>
                <p:sp>
                  <p:nvSpPr>
                    <p:cNvPr id="165" name="ZoneTexte 164">
                      <a:extLst>
                        <a:ext uri="{FF2B5EF4-FFF2-40B4-BE49-F238E27FC236}">
                          <a16:creationId xmlns:a16="http://schemas.microsoft.com/office/drawing/2014/main" id="{4EE57982-9C49-61A3-8851-CA90F5E64D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377737" y="3616122"/>
                      <a:ext cx="97819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 kDa</a:t>
                      </a:r>
                    </a:p>
                  </p:txBody>
                </p:sp>
              </p:grpSp>
              <p:grpSp>
                <p:nvGrpSpPr>
                  <p:cNvPr id="151" name="Groupe 150">
                    <a:extLst>
                      <a:ext uri="{FF2B5EF4-FFF2-40B4-BE49-F238E27FC236}">
                        <a16:creationId xmlns:a16="http://schemas.microsoft.com/office/drawing/2014/main" id="{DB60CA02-C416-78FB-102B-3D3AD751A170}"/>
                      </a:ext>
                    </a:extLst>
                  </p:cNvPr>
                  <p:cNvGrpSpPr/>
                  <p:nvPr/>
                </p:nvGrpSpPr>
                <p:grpSpPr>
                  <a:xfrm>
                    <a:off x="4574377" y="4953916"/>
                    <a:ext cx="2169412" cy="998329"/>
                    <a:chOff x="4574377" y="4953916"/>
                    <a:chExt cx="2169412" cy="998329"/>
                  </a:xfrm>
                </p:grpSpPr>
                <p:sp>
                  <p:nvSpPr>
                    <p:cNvPr id="152" name="ZoneTexte 151">
                      <a:extLst>
                        <a:ext uri="{FF2B5EF4-FFF2-40B4-BE49-F238E27FC236}">
                          <a16:creationId xmlns:a16="http://schemas.microsoft.com/office/drawing/2014/main" id="{BED44616-1A56-020B-B3C1-B26517D746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74377" y="5205541"/>
                      <a:ext cx="65950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</a:p>
                  </p:txBody>
                </p:sp>
                <p:sp>
                  <p:nvSpPr>
                    <p:cNvPr id="153" name="ZoneTexte 152">
                      <a:extLst>
                        <a:ext uri="{FF2B5EF4-FFF2-40B4-BE49-F238E27FC236}">
                          <a16:creationId xmlns:a16="http://schemas.microsoft.com/office/drawing/2014/main" id="{DC9E0F86-E15D-A2A8-66AB-D88610B5D5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46050" y="5196889"/>
                      <a:ext cx="78094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CA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endParaRPr lang="fr-CA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54" name="ZoneTexte 153">
                      <a:extLst>
                        <a:ext uri="{FF2B5EF4-FFF2-40B4-BE49-F238E27FC236}">
                          <a16:creationId xmlns:a16="http://schemas.microsoft.com/office/drawing/2014/main" id="{E2B2A081-AF0D-36D9-26E9-C62EE227C4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21628" y="5213067"/>
                      <a:ext cx="67950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J633</a:t>
                      </a:r>
                    </a:p>
                  </p:txBody>
                </p:sp>
                <p:sp>
                  <p:nvSpPr>
                    <p:cNvPr id="155" name="ZoneTexte 154">
                      <a:extLst>
                        <a:ext uri="{FF2B5EF4-FFF2-40B4-BE49-F238E27FC236}">
                          <a16:creationId xmlns:a16="http://schemas.microsoft.com/office/drawing/2014/main" id="{597BA1B5-BE6C-2BE9-CA4D-FEF3AE1B5F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162377" y="5213037"/>
                      <a:ext cx="58141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Z</a:t>
                      </a:r>
                    </a:p>
                  </p:txBody>
                </p:sp>
                <p:pic>
                  <p:nvPicPr>
                    <p:cNvPr id="156" name="Image 155" descr="Une image contenant texte&#10;&#10;Description générée automatiquement">
                      <a:extLst>
                        <a:ext uri="{FF2B5EF4-FFF2-40B4-BE49-F238E27FC236}">
                          <a16:creationId xmlns:a16="http://schemas.microsoft.com/office/drawing/2014/main" id="{C5D40D1F-C664-22C1-B5CB-4F3B5AF8B95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9407" t="60977" r="73662" b="34826"/>
                    <a:stretch/>
                  </p:blipFill>
                  <p:spPr>
                    <a:xfrm>
                      <a:off x="4615293" y="5408155"/>
                      <a:ext cx="540119" cy="261610"/>
                    </a:xfrm>
                    <a:prstGeom prst="rect">
                      <a:avLst/>
                    </a:prstGeom>
                    <a:ln w="19050">
                      <a:noFill/>
                    </a:ln>
                  </p:spPr>
                </p:pic>
                <p:cxnSp>
                  <p:nvCxnSpPr>
                    <p:cNvPr id="157" name="Connecteur droit 156">
                      <a:extLst>
                        <a:ext uri="{FF2B5EF4-FFF2-40B4-BE49-F238E27FC236}">
                          <a16:creationId xmlns:a16="http://schemas.microsoft.com/office/drawing/2014/main" id="{D7C80A81-98B6-D9DC-2B80-E73966B1D6E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213503" y="5200427"/>
                      <a:ext cx="1354297" cy="0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8" name="ZoneTexte 157">
                      <a:extLst>
                        <a:ext uri="{FF2B5EF4-FFF2-40B4-BE49-F238E27FC236}">
                          <a16:creationId xmlns:a16="http://schemas.microsoft.com/office/drawing/2014/main" id="{B77A8EAB-D478-28AC-AAB4-C04044B1D80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25566" y="4953916"/>
                      <a:ext cx="102944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1 µg/</a:t>
                      </a:r>
                      <a:r>
                        <a:rPr lang="fr-CA" sz="9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</a:t>
                      </a:r>
                      <a:r>
                        <a:rPr lang="fr-CA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l-6</a:t>
                      </a:r>
                    </a:p>
                  </p:txBody>
                </p:sp>
                <p:pic>
                  <p:nvPicPr>
                    <p:cNvPr id="159" name="Image 158" descr="Une image contenant texte&#10;&#10;Description générée automatiquement">
                      <a:extLst>
                        <a:ext uri="{FF2B5EF4-FFF2-40B4-BE49-F238E27FC236}">
                          <a16:creationId xmlns:a16="http://schemas.microsoft.com/office/drawing/2014/main" id="{B7886466-A3FF-1E48-EA3C-7A3CE0301D5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1258" t="52122" r="71315" b="43638"/>
                    <a:stretch/>
                  </p:blipFill>
                  <p:spPr>
                    <a:xfrm>
                      <a:off x="4640641" y="5690572"/>
                      <a:ext cx="572862" cy="261673"/>
                    </a:xfrm>
                    <a:prstGeom prst="rect">
                      <a:avLst/>
                    </a:prstGeom>
                    <a:ln w="19050">
                      <a:noFill/>
                    </a:ln>
                  </p:spPr>
                </p:pic>
              </p:grpSp>
            </p:grpSp>
            <p:pic>
              <p:nvPicPr>
                <p:cNvPr id="147" name="Image 146" descr="Une image contenant texte&#10;&#10;Description générée automatiquement">
                  <a:extLst>
                    <a:ext uri="{FF2B5EF4-FFF2-40B4-BE49-F238E27FC236}">
                      <a16:creationId xmlns:a16="http://schemas.microsoft.com/office/drawing/2014/main" id="{2B70CEA0-D74E-8E3D-D294-22CABD6FD4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772" t="60977" r="63298" b="35208"/>
                <a:stretch/>
              </p:blipFill>
              <p:spPr>
                <a:xfrm>
                  <a:off x="3247086" y="4772825"/>
                  <a:ext cx="540119" cy="261547"/>
                </a:xfrm>
                <a:prstGeom prst="rect">
                  <a:avLst/>
                </a:prstGeom>
                <a:ln w="19050">
                  <a:noFill/>
                </a:ln>
              </p:spPr>
            </p:pic>
            <p:pic>
              <p:nvPicPr>
                <p:cNvPr id="148" name="Image 147" descr="Une image contenant texte&#10;&#10;Description générée automatiquement">
                  <a:extLst>
                    <a:ext uri="{FF2B5EF4-FFF2-40B4-BE49-F238E27FC236}">
                      <a16:creationId xmlns:a16="http://schemas.microsoft.com/office/drawing/2014/main" id="{0FEF2FAC-3098-2B19-C666-CD69EE42CB2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649" t="61095" r="49676" b="34761"/>
                <a:stretch/>
              </p:blipFill>
              <p:spPr>
                <a:xfrm>
                  <a:off x="3778462" y="4774406"/>
                  <a:ext cx="520192" cy="258322"/>
                </a:xfrm>
                <a:prstGeom prst="rect">
                  <a:avLst/>
                </a:prstGeom>
                <a:ln w="19050">
                  <a:noFill/>
                </a:ln>
              </p:spPr>
            </p:pic>
            <p:pic>
              <p:nvPicPr>
                <p:cNvPr id="149" name="Image 148" descr="Une image contenant texte&#10;&#10;Description générée automatiquement">
                  <a:extLst>
                    <a:ext uri="{FF2B5EF4-FFF2-40B4-BE49-F238E27FC236}">
                      <a16:creationId xmlns:a16="http://schemas.microsoft.com/office/drawing/2014/main" id="{8D35D761-DCA7-1563-3502-95F490EF63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829" t="61508" r="36239" b="34347"/>
                <a:stretch/>
              </p:blipFill>
              <p:spPr>
                <a:xfrm>
                  <a:off x="4294334" y="4774406"/>
                  <a:ext cx="469722" cy="258322"/>
                </a:xfrm>
                <a:prstGeom prst="rect">
                  <a:avLst/>
                </a:prstGeom>
                <a:ln w="19050">
                  <a:noFill/>
                </a:ln>
              </p:spPr>
            </p:pic>
          </p:grpSp>
          <p:pic>
            <p:nvPicPr>
              <p:cNvPr id="143" name="Image 142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C17CF55F-AFE0-35E0-8792-77651BFF8C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78" t="51571" r="60792" b="44333"/>
              <a:stretch/>
            </p:blipFill>
            <p:spPr>
              <a:xfrm>
                <a:off x="3293669" y="5055211"/>
                <a:ext cx="519069" cy="252699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144" name="Image 143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4DE081DD-D46C-6184-6942-689FEACCFC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286" t="52097" r="47418" b="43679"/>
              <a:stretch/>
            </p:blipFill>
            <p:spPr>
              <a:xfrm>
                <a:off x="3808680" y="5056143"/>
                <a:ext cx="485653" cy="260709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145" name="Image 144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4F0B34E8-1872-CF69-4F91-C36BCFEA48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318" t="52095" r="34386" b="43636"/>
              <a:stretch/>
            </p:blipFill>
            <p:spPr>
              <a:xfrm>
                <a:off x="4286764" y="5056143"/>
                <a:ext cx="485653" cy="263317"/>
              </a:xfrm>
              <a:prstGeom prst="rect">
                <a:avLst/>
              </a:prstGeom>
              <a:ln w="19050">
                <a:noFill/>
              </a:ln>
            </p:spPr>
          </p:pic>
        </p:grp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2D00047C-54C3-06A0-EA90-C6F88E11723C}"/>
                </a:ext>
              </a:extLst>
            </p:cNvPr>
            <p:cNvSpPr/>
            <p:nvPr/>
          </p:nvSpPr>
          <p:spPr>
            <a:xfrm>
              <a:off x="2706967" y="4772762"/>
              <a:ext cx="2065450" cy="255954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9408D350-BE53-B31D-3954-4535D8B8E0DC}"/>
                </a:ext>
              </a:extLst>
            </p:cNvPr>
            <p:cNvSpPr/>
            <p:nvPr/>
          </p:nvSpPr>
          <p:spPr>
            <a:xfrm>
              <a:off x="2736901" y="5051956"/>
              <a:ext cx="2035516" cy="255954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166" name="Rectangle 165">
            <a:extLst>
              <a:ext uri="{FF2B5EF4-FFF2-40B4-BE49-F238E27FC236}">
                <a16:creationId xmlns:a16="http://schemas.microsoft.com/office/drawing/2014/main" id="{46E37D1E-CE9B-15A8-0107-38ACF14F75D1}"/>
              </a:ext>
            </a:extLst>
          </p:cNvPr>
          <p:cNvSpPr/>
          <p:nvPr/>
        </p:nvSpPr>
        <p:spPr>
          <a:xfrm>
            <a:off x="1958504" y="2851320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B73D9260-0FF0-FE7E-F278-6117E5CC73F9}"/>
              </a:ext>
            </a:extLst>
          </p:cNvPr>
          <p:cNvSpPr/>
          <p:nvPr/>
        </p:nvSpPr>
        <p:spPr>
          <a:xfrm>
            <a:off x="3006553" y="2851320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D89FD738-30DB-ABA0-AABC-AFA8FD1589F5}"/>
              </a:ext>
            </a:extLst>
          </p:cNvPr>
          <p:cNvSpPr/>
          <p:nvPr/>
        </p:nvSpPr>
        <p:spPr>
          <a:xfrm>
            <a:off x="4084385" y="2884572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6A9BA8E4-CB20-276D-2134-D0A325678619}"/>
              </a:ext>
            </a:extLst>
          </p:cNvPr>
          <p:cNvSpPr/>
          <p:nvPr/>
        </p:nvSpPr>
        <p:spPr>
          <a:xfrm>
            <a:off x="7129090" y="2770098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F2DA8635-5B4A-D85D-3220-CE61FF2355C4}"/>
              </a:ext>
            </a:extLst>
          </p:cNvPr>
          <p:cNvSpPr/>
          <p:nvPr/>
        </p:nvSpPr>
        <p:spPr>
          <a:xfrm>
            <a:off x="7947960" y="2770098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31867ACB-7EF7-1F03-DBFB-219F35B6A10D}"/>
              </a:ext>
            </a:extLst>
          </p:cNvPr>
          <p:cNvSpPr/>
          <p:nvPr/>
        </p:nvSpPr>
        <p:spPr>
          <a:xfrm>
            <a:off x="8996009" y="2770098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218314C5-8D31-7E26-BE71-0E462CE4C885}"/>
              </a:ext>
            </a:extLst>
          </p:cNvPr>
          <p:cNvSpPr/>
          <p:nvPr/>
        </p:nvSpPr>
        <p:spPr>
          <a:xfrm>
            <a:off x="10034085" y="2803350"/>
            <a:ext cx="526712" cy="2029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76865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02</Words>
  <Application>Microsoft Macintosh PowerPoint</Application>
  <PresentationFormat>Grand écran</PresentationFormat>
  <Paragraphs>8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ce Côté</dc:creator>
  <cp:lastModifiedBy>France Côté</cp:lastModifiedBy>
  <cp:revision>1</cp:revision>
  <dcterms:created xsi:type="dcterms:W3CDTF">2024-11-08T17:04:22Z</dcterms:created>
  <dcterms:modified xsi:type="dcterms:W3CDTF">2024-11-08T17:15:46Z</dcterms:modified>
</cp:coreProperties>
</file>